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72" r:id="rId1"/>
  </p:sldMasterIdLst>
  <p:notesMasterIdLst>
    <p:notesMasterId r:id="rId5"/>
  </p:notesMasterIdLst>
  <p:handoutMasterIdLst>
    <p:handoutMasterId r:id="rId6"/>
  </p:handoutMasterIdLst>
  <p:sldIdLst>
    <p:sldId id="272" r:id="rId2"/>
    <p:sldId id="266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86" d="100"/>
          <a:sy n="86" d="100"/>
        </p:scale>
        <p:origin x="-3186" y="-3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customXml" Target="../customXml/item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EF17C7-1DBA-4952-AFC2-B9862AB84BD8}" type="datetimeFigureOut">
              <a:rPr lang="en-US" smtClean="0"/>
              <a:t>6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F32545-A985-487B-BCCE-2D5F488E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99587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DC6691-9CE2-4545-A6BC-5E2BF56B6581}" type="datetimeFigureOut">
              <a:rPr lang="en-US" smtClean="0"/>
              <a:t>6/2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FE6B9E-6265-4525-8ED8-D919F97DC2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271890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ED837-0AC1-4CD2-930F-CA197E1E40F5}" type="datetime1">
              <a:rPr lang="en-US" smtClean="0"/>
              <a:t>6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380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FD0C9-5508-42FF-B749-21D612370732}" type="datetime1">
              <a:rPr lang="en-US" smtClean="0"/>
              <a:t>6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802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408D84-9FF9-4A77-BA75-14AF100DEB32}" type="datetime1">
              <a:rPr lang="en-US" smtClean="0"/>
              <a:t>6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07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91E5D-CAD6-4E88-9D15-9B1D5F5D1113}" type="datetime1">
              <a:rPr lang="en-US" smtClean="0"/>
              <a:t>6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38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F82C7-4752-4CD2-9D31-36F0F6BAE494}" type="datetime1">
              <a:rPr lang="en-US" smtClean="0"/>
              <a:t>6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2711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905F-865F-4BA6-A5C2-678AECDED887}" type="datetime1">
              <a:rPr lang="en-US" smtClean="0"/>
              <a:t>6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075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3CA6-03D9-46BA-9F60-842775FE67F3}" type="datetime1">
              <a:rPr lang="en-US" smtClean="0"/>
              <a:t>6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268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86E8-D586-4E0A-9488-356D8A79932A}" type="datetime1">
              <a:rPr lang="en-US" smtClean="0"/>
              <a:t>6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078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8A7F1-6C52-41ED-B9E2-905E1E0BF177}" type="datetime1">
              <a:rPr lang="en-US" smtClean="0"/>
              <a:t>6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766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0563A-FC98-421D-BBEA-13D01858B884}" type="datetime1">
              <a:rPr lang="en-US" smtClean="0"/>
              <a:t>6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719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96FAC-FDBE-467B-9962-FAC2A68281DC}" type="datetime1">
              <a:rPr lang="en-US" smtClean="0"/>
              <a:t>6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37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51949-F6DB-4B76-9D65-6963BBBE4B72}" type="datetime1">
              <a:rPr lang="en-US" smtClean="0"/>
              <a:t>6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6F2DD-C5F5-495A-BC65-92542605A3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47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1106" y="352479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b="1" dirty="0" smtClean="0"/>
              <a:t>S1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47690" y="1005935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3483179" y="101246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739" y="1381792"/>
            <a:ext cx="3200400" cy="24003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6088" y="1381792"/>
            <a:ext cx="3200400" cy="2400300"/>
          </a:xfrm>
          <a:prstGeom prst="rect">
            <a:avLst/>
          </a:prstGeom>
        </p:spPr>
      </p:pic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681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1970986"/>
            <a:ext cx="3200400" cy="216363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8855" y="473317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S2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28600" y="1601654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447288" y="160165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36090" y="406343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454778" y="406343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1970986"/>
            <a:ext cx="3200400" cy="2163637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8600" y="4452303"/>
            <a:ext cx="3200400" cy="216363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9000" y="4452304"/>
            <a:ext cx="3200400" cy="2163635"/>
          </a:xfrm>
          <a:prstGeom prst="rect">
            <a:avLst/>
          </a:prstGeom>
        </p:spPr>
      </p:pic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7630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152" y="3952170"/>
            <a:ext cx="3200400" cy="216363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11106" y="352479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b="1" dirty="0" smtClean="0"/>
              <a:t>S3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84895" y="1141791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461912" y="114179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86220" y="364777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463237" y="364777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8534" y="1511124"/>
            <a:ext cx="3200400" cy="2163636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152" y="1511124"/>
            <a:ext cx="3200400" cy="2163636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4895" y="6360364"/>
            <a:ext cx="3994941" cy="21945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48534" y="3952169"/>
            <a:ext cx="3200400" cy="216363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89761" y="603301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6F2DD-C5F5-495A-BC65-92542605A32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1991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52B5BFDE3710D4D8B1F7A20CD5CBC59" ma:contentTypeVersion="7" ma:contentTypeDescription="Create a new document." ma:contentTypeScope="" ma:versionID="30006c9b4a420989a9d4913f5fb5e4c2">
  <xsd:schema xmlns:xsd="http://www.w3.org/2001/XMLSchema" xmlns:p="http://schemas.microsoft.com/office/2006/metadata/properties" xmlns:ns2="ba6ec54f-db9a-49af-86be-c92c4fde1990" targetNamespace="http://schemas.microsoft.com/office/2006/metadata/properties" ma:root="true" ma:fieldsID="9845ea47f6466e6c3d7fc9c8c28bea65" ns2:_="">
    <xsd:import namespace="ba6ec54f-db9a-49af-86be-c92c4fde199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a6ec54f-db9a-49af-86be-c92c4fde199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a6ec54f-db9a-49af-86be-c92c4fde1990">
      <UserInfo>
        <DisplayName/>
        <AccountId xsi:nil="true"/>
        <AccountType/>
      </UserInfo>
    </Checked_x0020_Out_x0020_To>
    <IsDeleted xmlns="ba6ec54f-db9a-49af-86be-c92c4fde1990">false</IsDeleted>
    <DocumentId xmlns="ba6ec54f-db9a-49af-86be-c92c4fde1990">Presentation 1.PPTX</DocumentId>
    <StageName xmlns="ba6ec54f-db9a-49af-86be-c92c4fde1990" xsi:nil="true"/>
    <TitleName xmlns="ba6ec54f-db9a-49af-86be-c92c4fde1990">Presentation 1.PPTX</TitleName>
    <FileFormat xmlns="ba6ec54f-db9a-49af-86be-c92c4fde1990">PPTX</FileFormat>
    <DocumentType xmlns="ba6ec54f-db9a-49af-86be-c92c4fde1990">Presentation</DocumentType>
  </documentManagement>
</p:properties>
</file>

<file path=customXml/itemProps1.xml><?xml version="1.0" encoding="utf-8"?>
<ds:datastoreItem xmlns:ds="http://schemas.openxmlformats.org/officeDocument/2006/customXml" ds:itemID="{DB356528-3F85-4A6A-9CD5-432B79EA57F7}"/>
</file>

<file path=customXml/itemProps2.xml><?xml version="1.0" encoding="utf-8"?>
<ds:datastoreItem xmlns:ds="http://schemas.openxmlformats.org/officeDocument/2006/customXml" ds:itemID="{C595E8A4-5AC3-4C23-A6A6-93D4661CCAC1}"/>
</file>

<file path=customXml/itemProps3.xml><?xml version="1.0" encoding="utf-8"?>
<ds:datastoreItem xmlns:ds="http://schemas.openxmlformats.org/officeDocument/2006/customXml" ds:itemID="{AC086B25-C4F5-4541-8199-37DD3BD766F7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7</TotalTime>
  <Words>23</Words>
  <Application>Microsoft Office PowerPoint</Application>
  <PresentationFormat>A4 Paper (210x297 mm)</PresentationFormat>
  <Paragraphs>1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</dc:title>
  <dc:creator>Song Lu</dc:creator>
  <cp:lastModifiedBy>kathy</cp:lastModifiedBy>
  <cp:revision>171</cp:revision>
  <dcterms:created xsi:type="dcterms:W3CDTF">2016-05-18T08:12:40Z</dcterms:created>
  <dcterms:modified xsi:type="dcterms:W3CDTF">2017-06-26T06:11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52B5BFDE3710D4D8B1F7A20CD5CBC59</vt:lpwstr>
  </property>
</Properties>
</file>